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Masters/slideMaster1.xml" ContentType="application/vnd.openxmlformats-officedocument.presentationml.slideMaster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Masters/notesMaster1.xml" ContentType="application/vnd.openxmlformats-officedocument.presentationml.notesMaster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2.xml" ContentType="application/vnd.openxmlformats-officedocument.theme+xml"/>
  <Override PartName="/ppt/commentAuthors.xml" ContentType="application/vnd.openxmlformats-officedocument.presentationml.commentAuthors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5"/>
  </p:notesMasterIdLst>
  <p:sldIdLst>
    <p:sldId id="262" r:id="rId2"/>
    <p:sldId id="263" r:id="rId3"/>
    <p:sldId id="264" r:id="rId4"/>
  </p:sldIdLst>
  <p:sldSz cx="13208000" cy="990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4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ünkel, Anna" initials="DA" lastIdx="1" clrIdx="0">
    <p:extLst>
      <p:ext uri="{19B8F6BF-5375-455C-9EA6-DF929625EA0E}">
        <p15:presenceInfo xmlns:p15="http://schemas.microsoft.com/office/powerpoint/2012/main" userId="S::anna.duenkel@izi.fraunhofer.de::389e6d3e-fe5d-4347-91b8-7bb40b548a3f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6" autoAdjust="0"/>
    <p:restoredTop sz="94660"/>
  </p:normalViewPr>
  <p:slideViewPr>
    <p:cSldViewPr snapToGrid="0" showGuides="1">
      <p:cViewPr varScale="1">
        <p:scale>
          <a:sx n="76" d="100"/>
          <a:sy n="76" d="100"/>
        </p:scale>
        <p:origin x="1626" y="108"/>
      </p:cViewPr>
      <p:guideLst>
        <p:guide orient="horz" pos="3120"/>
        <p:guide pos="4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13" Type="http://schemas.openxmlformats.org/officeDocument/2006/relationships/customXml" Target="../customXml/item3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openxmlformats.org/officeDocument/2006/relationships/customXml" Target="../customXml/item2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11" Type="http://schemas.openxmlformats.org/officeDocument/2006/relationships/customXml" Target="../customXml/item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ranos.izi.fraunhofer.de\oe_700$\03.Projekte%20GMPDU\Cellbox\Cellbox_Berichte\Paper\20250107_CB_Paper_final\supplement_data\Supplemental_data_02_Cellcount\20250108_Cellcounts_Donor%201-6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de-DE"/>
              <a:t>Cumulative Population Doublings [CPD] </a:t>
            </a:r>
          </a:p>
          <a:p>
            <a:pPr>
              <a:defRPr/>
            </a:pPr>
            <a:r>
              <a:rPr lang="de-DE"/>
              <a:t>of Donor 1 to 6</a:t>
            </a:r>
          </a:p>
          <a:p>
            <a:pPr>
              <a:defRPr/>
            </a:pPr>
            <a:r>
              <a:rPr lang="de-DE"/>
              <a:t>during NK cell expansion</a:t>
            </a:r>
          </a:p>
        </c:rich>
      </c:tx>
      <c:layout>
        <c:manualLayout>
          <c:xMode val="edge"/>
          <c:yMode val="edge"/>
          <c:x val="0.29120652887139109"/>
          <c:y val="7.665505226480835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0.13512137831020149"/>
          <c:y val="0.1911381514358429"/>
          <c:w val="0.8129850791997304"/>
          <c:h val="0.69040552832112223"/>
        </c:manualLayout>
      </c:layout>
      <c:scatterChart>
        <c:scatterStyle val="lineMarker"/>
        <c:varyColors val="0"/>
        <c:ser>
          <c:idx val="0"/>
          <c:order val="0"/>
          <c:tx>
            <c:v>Donor 1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00_NKC expansion_phase'!$C$20:$X$20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3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9</c:v>
                </c:pt>
                <c:pt idx="9">
                  <c:v>10</c:v>
                </c:pt>
                <c:pt idx="10">
                  <c:v>12</c:v>
                </c:pt>
                <c:pt idx="11">
                  <c:v>13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6</c:v>
                </c:pt>
                <c:pt idx="17">
                  <c:v>17</c:v>
                </c:pt>
                <c:pt idx="18">
                  <c:v>19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</c:numCache>
            </c:numRef>
          </c:xVal>
          <c:yVal>
            <c:numRef>
              <c:f>'00_NKC expansion_phase'!$C$21:$X$21</c:f>
              <c:numCache>
                <c:formatCode>0.00</c:formatCode>
                <c:ptCount val="22"/>
                <c:pt idx="0">
                  <c:v>-9.1889845395737468E-2</c:v>
                </c:pt>
                <c:pt idx="1">
                  <c:v>#N/A</c:v>
                </c:pt>
                <c:pt idx="2">
                  <c:v>0.10974838025896097</c:v>
                </c:pt>
                <c:pt idx="3">
                  <c:v>#N/A</c:v>
                </c:pt>
                <c:pt idx="4">
                  <c:v>0.49908418765499529</c:v>
                </c:pt>
                <c:pt idx="5" formatCode="0.00E+00">
                  <c:v>#N/A</c:v>
                </c:pt>
                <c:pt idx="6">
                  <c:v>1.277179674297344</c:v>
                </c:pt>
                <c:pt idx="7">
                  <c:v>#N/A</c:v>
                </c:pt>
                <c:pt idx="8" formatCode="0.00E+00">
                  <c:v>#N/A</c:v>
                </c:pt>
                <c:pt idx="9">
                  <c:v>2.1541867517460647</c:v>
                </c:pt>
                <c:pt idx="10">
                  <c:v>#N/A</c:v>
                </c:pt>
                <c:pt idx="11">
                  <c:v>2.6563624904651792</c:v>
                </c:pt>
                <c:pt idx="12" formatCode="0.00E+00">
                  <c:v>#N/A</c:v>
                </c:pt>
                <c:pt idx="13">
                  <c:v>#N/A</c:v>
                </c:pt>
                <c:pt idx="14">
                  <c:v>3.0461938323122766</c:v>
                </c:pt>
                <c:pt idx="15">
                  <c:v>#N/A</c:v>
                </c:pt>
                <c:pt idx="16">
                  <c:v>#N/A</c:v>
                </c:pt>
                <c:pt idx="17">
                  <c:v>3.578649153157218</c:v>
                </c:pt>
                <c:pt idx="18">
                  <c:v>#N/A</c:v>
                </c:pt>
                <c:pt idx="19">
                  <c:v>#N/A</c:v>
                </c:pt>
                <c:pt idx="20">
                  <c:v>3.5253497733253161</c:v>
                </c:pt>
                <c:pt idx="21">
                  <c:v>#N/A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30C-4582-A19D-B2C0E0DA00A6}"/>
            </c:ext>
          </c:extLst>
        </c:ser>
        <c:ser>
          <c:idx val="1"/>
          <c:order val="1"/>
          <c:tx>
            <c:v>Donor 2</c:v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00_NKC expansion_phase'!$C$20:$X$20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3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9</c:v>
                </c:pt>
                <c:pt idx="9">
                  <c:v>10</c:v>
                </c:pt>
                <c:pt idx="10">
                  <c:v>12</c:v>
                </c:pt>
                <c:pt idx="11">
                  <c:v>13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6</c:v>
                </c:pt>
                <c:pt idx="17">
                  <c:v>17</c:v>
                </c:pt>
                <c:pt idx="18">
                  <c:v>19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</c:numCache>
            </c:numRef>
          </c:xVal>
          <c:yVal>
            <c:numRef>
              <c:f>'00_NKC expansion_phase'!$C$22:$X$22</c:f>
              <c:numCache>
                <c:formatCode>0.00</c:formatCode>
                <c:ptCount val="22"/>
                <c:pt idx="0">
                  <c:v>-0.39624636895317294</c:v>
                </c:pt>
                <c:pt idx="1">
                  <c:v>-0.136908478835711</c:v>
                </c:pt>
                <c:pt idx="2">
                  <c:v>#N/A</c:v>
                </c:pt>
                <c:pt idx="3">
                  <c:v>0.60877606594365896</c:v>
                </c:pt>
                <c:pt idx="4">
                  <c:v>#N/A</c:v>
                </c:pt>
                <c:pt idx="5" formatCode="0.00E+00">
                  <c:v>#N/A</c:v>
                </c:pt>
                <c:pt idx="6">
                  <c:v>0.90495133035713737</c:v>
                </c:pt>
                <c:pt idx="7">
                  <c:v>2.4399154835557662</c:v>
                </c:pt>
                <c:pt idx="8" formatCode="0.00E+00">
                  <c:v>#N/A</c:v>
                </c:pt>
                <c:pt idx="9">
                  <c:v>#N/A</c:v>
                </c:pt>
                <c:pt idx="10">
                  <c:v>3.0741486829692786</c:v>
                </c:pt>
                <c:pt idx="11">
                  <c:v>#N/A</c:v>
                </c:pt>
                <c:pt idx="12" formatCode="0.00E+00">
                  <c:v>#N/A</c:v>
                </c:pt>
                <c:pt idx="13">
                  <c:v>3.9861122458714209</c:v>
                </c:pt>
                <c:pt idx="14">
                  <c:v>#N/A</c:v>
                </c:pt>
                <c:pt idx="15">
                  <c:v>5.0587584752964148</c:v>
                </c:pt>
                <c:pt idx="16">
                  <c:v>#N/A</c:v>
                </c:pt>
                <c:pt idx="17">
                  <c:v>#N/A</c:v>
                </c:pt>
                <c:pt idx="18">
                  <c:v>#N/A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30C-4582-A19D-B2C0E0DA00A6}"/>
            </c:ext>
          </c:extLst>
        </c:ser>
        <c:ser>
          <c:idx val="2"/>
          <c:order val="2"/>
          <c:tx>
            <c:v>Donor 3</c:v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00_NKC expansion_phase'!$C$20:$X$20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3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9</c:v>
                </c:pt>
                <c:pt idx="9">
                  <c:v>10</c:v>
                </c:pt>
                <c:pt idx="10">
                  <c:v>12</c:v>
                </c:pt>
                <c:pt idx="11">
                  <c:v>13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6</c:v>
                </c:pt>
                <c:pt idx="17">
                  <c:v>17</c:v>
                </c:pt>
                <c:pt idx="18">
                  <c:v>19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</c:numCache>
            </c:numRef>
          </c:xVal>
          <c:yVal>
            <c:numRef>
              <c:f>'00_NKC expansion_phase'!$C$23:$X$23</c:f>
              <c:numCache>
                <c:formatCode>0.00</c:formatCode>
                <c:ptCount val="22"/>
                <c:pt idx="0">
                  <c:v>-0.50072097715372088</c:v>
                </c:pt>
                <c:pt idx="1">
                  <c:v>0.2278884743823576</c:v>
                </c:pt>
                <c:pt idx="2">
                  <c:v>#N/A</c:v>
                </c:pt>
                <c:pt idx="3">
                  <c:v>1.2176519925741898</c:v>
                </c:pt>
                <c:pt idx="4">
                  <c:v>#N/A</c:v>
                </c:pt>
                <c:pt idx="5" formatCode="0.00E+00">
                  <c:v>#N/A</c:v>
                </c:pt>
                <c:pt idx="6">
                  <c:v>1.6293856698400253</c:v>
                </c:pt>
                <c:pt idx="7">
                  <c:v>3.0629901511076847</c:v>
                </c:pt>
                <c:pt idx="8" formatCode="0.00E+00">
                  <c:v>#N/A</c:v>
                </c:pt>
                <c:pt idx="9">
                  <c:v>#N/A</c:v>
                </c:pt>
                <c:pt idx="10">
                  <c:v>3.5813757915084046</c:v>
                </c:pt>
                <c:pt idx="11">
                  <c:v>#N/A</c:v>
                </c:pt>
                <c:pt idx="12" formatCode="0.00E+00">
                  <c:v>#N/A</c:v>
                </c:pt>
                <c:pt idx="13">
                  <c:v>4.1723391535463188</c:v>
                </c:pt>
                <c:pt idx="14">
                  <c:v>#N/A</c:v>
                </c:pt>
                <c:pt idx="15">
                  <c:v>5.4866493895242598</c:v>
                </c:pt>
                <c:pt idx="16">
                  <c:v>#N/A</c:v>
                </c:pt>
                <c:pt idx="17">
                  <c:v>#N/A</c:v>
                </c:pt>
                <c:pt idx="18">
                  <c:v>#N/A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30C-4582-A19D-B2C0E0DA00A6}"/>
            </c:ext>
          </c:extLst>
        </c:ser>
        <c:ser>
          <c:idx val="3"/>
          <c:order val="3"/>
          <c:tx>
            <c:v>Donor 4</c:v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00_NKC expansion_phase'!$C$20:$X$20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3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9</c:v>
                </c:pt>
                <c:pt idx="9">
                  <c:v>10</c:v>
                </c:pt>
                <c:pt idx="10">
                  <c:v>12</c:v>
                </c:pt>
                <c:pt idx="11">
                  <c:v>13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6</c:v>
                </c:pt>
                <c:pt idx="17">
                  <c:v>17</c:v>
                </c:pt>
                <c:pt idx="18">
                  <c:v>19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</c:numCache>
            </c:numRef>
          </c:xVal>
          <c:yVal>
            <c:numRef>
              <c:f>'00_NKC expansion_phase'!$C$24:$X$24</c:f>
              <c:numCache>
                <c:formatCode>0.00</c:formatCode>
                <c:ptCount val="22"/>
                <c:pt idx="0">
                  <c:v>-0.29156075671351589</c:v>
                </c:pt>
                <c:pt idx="1">
                  <c:v>3.2948305877618655E-2</c:v>
                </c:pt>
                <c:pt idx="2">
                  <c:v>#N/A</c:v>
                </c:pt>
                <c:pt idx="3">
                  <c:v>0.80883338648743852</c:v>
                </c:pt>
                <c:pt idx="4">
                  <c:v>#N/A</c:v>
                </c:pt>
                <c:pt idx="5">
                  <c:v>1.5893753434632494</c:v>
                </c:pt>
                <c:pt idx="6">
                  <c:v>#N/A</c:v>
                </c:pt>
                <c:pt idx="7">
                  <c:v>2.9310547580836372</c:v>
                </c:pt>
                <c:pt idx="8" formatCode="0.00E+00">
                  <c:v>#N/A</c:v>
                </c:pt>
                <c:pt idx="9">
                  <c:v>#N/A</c:v>
                </c:pt>
                <c:pt idx="10">
                  <c:v>#N/A</c:v>
                </c:pt>
                <c:pt idx="11">
                  <c:v>3.5382448750026865</c:v>
                </c:pt>
                <c:pt idx="12" formatCode="0.00E+00">
                  <c:v>#N/A</c:v>
                </c:pt>
                <c:pt idx="13">
                  <c:v>#N/A</c:v>
                </c:pt>
                <c:pt idx="14">
                  <c:v>#N/A</c:v>
                </c:pt>
                <c:pt idx="15">
                  <c:v>4.4250342003576968</c:v>
                </c:pt>
                <c:pt idx="16">
                  <c:v>#N/A</c:v>
                </c:pt>
                <c:pt idx="17">
                  <c:v>#N/A</c:v>
                </c:pt>
                <c:pt idx="18">
                  <c:v>3.8055567438563767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30C-4582-A19D-B2C0E0DA00A6}"/>
            </c:ext>
          </c:extLst>
        </c:ser>
        <c:ser>
          <c:idx val="4"/>
          <c:order val="4"/>
          <c:tx>
            <c:v>Donor 5</c:v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00_NKC expansion_phase'!$C$20:$X$20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3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9</c:v>
                </c:pt>
                <c:pt idx="9">
                  <c:v>10</c:v>
                </c:pt>
                <c:pt idx="10">
                  <c:v>12</c:v>
                </c:pt>
                <c:pt idx="11">
                  <c:v>13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6</c:v>
                </c:pt>
                <c:pt idx="17">
                  <c:v>17</c:v>
                </c:pt>
                <c:pt idx="18">
                  <c:v>19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</c:numCache>
            </c:numRef>
          </c:xVal>
          <c:yVal>
            <c:numRef>
              <c:f>'00_NKC expansion_phase'!$C$25:$X$25</c:f>
              <c:numCache>
                <c:formatCode>0.00</c:formatCode>
                <c:ptCount val="22"/>
                <c:pt idx="0">
                  <c:v>-0.29487476083214287</c:v>
                </c:pt>
                <c:pt idx="1">
                  <c:v>-0.42656072025694181</c:v>
                </c:pt>
                <c:pt idx="2">
                  <c:v>#N/A</c:v>
                </c:pt>
                <c:pt idx="3">
                  <c:v>1.924547795607376</c:v>
                </c:pt>
                <c:pt idx="4">
                  <c:v>#N/A</c:v>
                </c:pt>
                <c:pt idx="5">
                  <c:v>#N/A</c:v>
                </c:pt>
                <c:pt idx="6">
                  <c:v>#N/A</c:v>
                </c:pt>
                <c:pt idx="7">
                  <c:v>3.1201167465488266</c:v>
                </c:pt>
                <c:pt idx="8" formatCode="0.00E+00">
                  <c:v>#N/A</c:v>
                </c:pt>
                <c:pt idx="9">
                  <c:v>#N/A</c:v>
                </c:pt>
                <c:pt idx="10">
                  <c:v>4.0678163948317234</c:v>
                </c:pt>
                <c:pt idx="11">
                  <c:v>#N/A</c:v>
                </c:pt>
                <c:pt idx="12" formatCode="0.00E+00">
                  <c:v>#N/A</c:v>
                </c:pt>
                <c:pt idx="13">
                  <c:v>4.9998605932798421</c:v>
                </c:pt>
                <c:pt idx="14">
                  <c:v>#N/A</c:v>
                </c:pt>
                <c:pt idx="15">
                  <c:v>6.1427879508238705</c:v>
                </c:pt>
                <c:pt idx="16">
                  <c:v>#N/A</c:v>
                </c:pt>
                <c:pt idx="17">
                  <c:v>#N/A</c:v>
                </c:pt>
                <c:pt idx="18">
                  <c:v>6.6102514625610382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530C-4582-A19D-B2C0E0DA00A6}"/>
            </c:ext>
          </c:extLst>
        </c:ser>
        <c:ser>
          <c:idx val="5"/>
          <c:order val="5"/>
          <c:tx>
            <c:v>Donor 6</c:v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00_NKC expansion_phase'!$C$20:$X$20</c:f>
              <c:numCache>
                <c:formatCode>General</c:formatCode>
                <c:ptCount val="22"/>
                <c:pt idx="0">
                  <c:v>0</c:v>
                </c:pt>
                <c:pt idx="1">
                  <c:v>2</c:v>
                </c:pt>
                <c:pt idx="2">
                  <c:v>3</c:v>
                </c:pt>
                <c:pt idx="3">
                  <c:v>5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  <c:pt idx="8">
                  <c:v>9</c:v>
                </c:pt>
                <c:pt idx="9">
                  <c:v>10</c:v>
                </c:pt>
                <c:pt idx="10">
                  <c:v>12</c:v>
                </c:pt>
                <c:pt idx="11">
                  <c:v>13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6</c:v>
                </c:pt>
                <c:pt idx="17">
                  <c:v>17</c:v>
                </c:pt>
                <c:pt idx="18">
                  <c:v>19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</c:numCache>
            </c:numRef>
          </c:xVal>
          <c:yVal>
            <c:numRef>
              <c:f>'00_NKC expansion_phase'!$C$26:$X$26</c:f>
              <c:numCache>
                <c:formatCode>0.00</c:formatCode>
                <c:ptCount val="22"/>
                <c:pt idx="0">
                  <c:v>-0.522330583702171</c:v>
                </c:pt>
                <c:pt idx="1">
                  <c:v>-0.19724866039498856</c:v>
                </c:pt>
                <c:pt idx="2">
                  <c:v>#N/A</c:v>
                </c:pt>
                <c:pt idx="3">
                  <c:v>1.0340312739033726</c:v>
                </c:pt>
                <c:pt idx="4">
                  <c:v>#N/A</c:v>
                </c:pt>
                <c:pt idx="5">
                  <c:v>#N/A</c:v>
                </c:pt>
                <c:pt idx="6">
                  <c:v>#N/A</c:v>
                </c:pt>
                <c:pt idx="7">
                  <c:v>2.0299842104936365</c:v>
                </c:pt>
                <c:pt idx="8" formatCode="0.00E+00">
                  <c:v>#N/A</c:v>
                </c:pt>
                <c:pt idx="9">
                  <c:v>#N/A</c:v>
                </c:pt>
                <c:pt idx="10">
                  <c:v>2.9113587914599548</c:v>
                </c:pt>
                <c:pt idx="11">
                  <c:v>#N/A</c:v>
                </c:pt>
                <c:pt idx="12" formatCode="0.00E+00">
                  <c:v>#N/A</c:v>
                </c:pt>
                <c:pt idx="13">
                  <c:v>3.7882394949302807</c:v>
                </c:pt>
                <c:pt idx="14">
                  <c:v>#N/A</c:v>
                </c:pt>
                <c:pt idx="15">
                  <c:v>4.808746005988632</c:v>
                </c:pt>
                <c:pt idx="16">
                  <c:v>#N/A</c:v>
                </c:pt>
                <c:pt idx="17">
                  <c:v>#N/A</c:v>
                </c:pt>
                <c:pt idx="18">
                  <c:v>5.2523622595944959</c:v>
                </c:pt>
                <c:pt idx="19">
                  <c:v>#N/A</c:v>
                </c:pt>
                <c:pt idx="20">
                  <c:v>#N/A</c:v>
                </c:pt>
                <c:pt idx="21">
                  <c:v>#N/A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530C-4582-A19D-B2C0E0DA00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37269311"/>
        <c:axId val="437256415"/>
      </c:scatterChart>
      <c:valAx>
        <c:axId val="437269311"/>
        <c:scaling>
          <c:orientation val="minMax"/>
          <c:max val="21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culture duration [d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437256415"/>
        <c:crosses val="autoZero"/>
        <c:crossBetween val="midCat"/>
      </c:valAx>
      <c:valAx>
        <c:axId val="43725641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/>
                  <a:t>Cumulative Population Doublings [CPD]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0.0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437269311"/>
        <c:crosses val="autoZero"/>
        <c:crossBetween val="midCat"/>
        <c:minorUnit val="0.5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legend>
    <c:plotVisOnly val="1"/>
    <c:dispBlanksAs val="span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B9BD82-6081-4B9B-BC8D-373543C35EEE}" type="datetimeFigureOut">
              <a:rPr lang="de-DE" smtClean="0"/>
              <a:t>10.04.20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B84FE5-BD21-4D58-B4E6-B60004F681F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2366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0600" y="1621191"/>
            <a:ext cx="112268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51000" y="5202944"/>
            <a:ext cx="99060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B2740-476B-4225-B97B-6E47C0E839D4}" type="datetime1">
              <a:rPr lang="de-DE" smtClean="0"/>
              <a:t>10.04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1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509364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078CC4-48D3-49E2-9882-AD87CDFD0420}" type="datetime1">
              <a:rPr lang="de-DE" smtClean="0"/>
              <a:t>10.04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1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8757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451976" y="527403"/>
            <a:ext cx="2847975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08051" y="527403"/>
            <a:ext cx="8378825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7D02C-0F4E-425A-AA28-403854CB61DB}" type="datetime1">
              <a:rPr lang="de-DE" smtClean="0"/>
              <a:t>10.04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1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2333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D01D30-BBC7-430D-A7DA-CE916AAF6B11}" type="datetime1">
              <a:rPr lang="de-DE" smtClean="0"/>
              <a:t>10.04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1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524680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1172" y="2469624"/>
            <a:ext cx="11391900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1172" y="6629226"/>
            <a:ext cx="11391900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/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764EBA-4D89-4106-872F-014349588AFC}" type="datetime1">
              <a:rPr lang="de-DE" smtClean="0"/>
              <a:t>10.04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1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08710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08050" y="2637014"/>
            <a:ext cx="561340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86550" y="2637014"/>
            <a:ext cx="561340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BB7B5E-3590-420E-A52E-8F97D46661D3}" type="datetime1">
              <a:rPr lang="de-DE" smtClean="0"/>
              <a:t>10.04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1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40982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527405"/>
            <a:ext cx="11391900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9772" y="2428347"/>
            <a:ext cx="5587602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09772" y="3618442"/>
            <a:ext cx="5587602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686551" y="2428347"/>
            <a:ext cx="5615120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686551" y="3618442"/>
            <a:ext cx="5615120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958251-ED91-456D-84AF-A609104DEDA2}" type="datetime1">
              <a:rPr lang="de-DE" smtClean="0"/>
              <a:t>10.04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1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0022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DFC88-FC44-4968-BB7C-263DC827C783}" type="datetime1">
              <a:rPr lang="de-DE" smtClean="0"/>
              <a:t>10.04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1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1027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6C91AF-AA69-4650-9375-DD3BAC31C033}" type="datetime1">
              <a:rPr lang="de-DE" smtClean="0"/>
              <a:t>10.04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17155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660400"/>
            <a:ext cx="425992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15120" y="1426283"/>
            <a:ext cx="6686550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2971800"/>
            <a:ext cx="425992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C9FBF3-97A0-4AD8-B551-7B61748F4CA2}" type="datetime1">
              <a:rPr lang="de-DE" smtClean="0"/>
              <a:t>10.04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1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81417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660400"/>
            <a:ext cx="425992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15120" y="1426283"/>
            <a:ext cx="6686550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2971800"/>
            <a:ext cx="425992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FC442-8523-4FCA-81EB-7EC1A2C719D8}" type="datetime1">
              <a:rPr lang="de-DE" smtClean="0"/>
              <a:t>10.04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de-DE"/>
              <a:t>1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6632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08050" y="527405"/>
            <a:ext cx="11391900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050" y="2637014"/>
            <a:ext cx="11391900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08050" y="9181397"/>
            <a:ext cx="29718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B604B9-A69E-4E32-B8DF-BB865D121414}" type="datetime1">
              <a:rPr lang="de-DE" smtClean="0"/>
              <a:t>10.04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375150" y="9181397"/>
            <a:ext cx="4457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de-DE"/>
              <a:t>1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328150" y="9181397"/>
            <a:ext cx="29718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A16D49-2449-4109-BE83-049B41A6F97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6540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hf hdr="0" dt="0"/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1FF474BC-1383-4F34-B625-EA150227C810}"/>
              </a:ext>
            </a:extLst>
          </p:cNvPr>
          <p:cNvSpPr txBox="1"/>
          <p:nvPr/>
        </p:nvSpPr>
        <p:spPr>
          <a:xfrm>
            <a:off x="3128662" y="8153400"/>
            <a:ext cx="535047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1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umulativ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opulat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oubling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1 – 6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uring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NK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xpans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has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up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21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Diagramm 6">
            <a:extLst>
              <a:ext uri="{FF2B5EF4-FFF2-40B4-BE49-F238E27FC236}">
                <a16:creationId xmlns:a16="http://schemas.microsoft.com/office/drawing/2014/main" id="{D94595DA-1DE3-4971-86CE-591BBAC1011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53009656"/>
              </p:ext>
            </p:extLst>
          </p:nvPr>
        </p:nvGraphicFramePr>
        <p:xfrm>
          <a:off x="2730500" y="863600"/>
          <a:ext cx="7315200" cy="7289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Foliennummernplatzhalter 2">
            <a:extLst>
              <a:ext uri="{FF2B5EF4-FFF2-40B4-BE49-F238E27FC236}">
                <a16:creationId xmlns:a16="http://schemas.microsoft.com/office/drawing/2014/main" id="{53CC49FF-5E0F-4D4B-B3B1-1B15157F7B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1</a:t>
            </a:fld>
            <a:endParaRPr lang="de-DE"/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719C88E3-28F0-4C53-9719-6F5B30BDD7BB}"/>
              </a:ext>
            </a:extLst>
          </p:cNvPr>
          <p:cNvSpPr txBox="1"/>
          <p:nvPr/>
        </p:nvSpPr>
        <p:spPr>
          <a:xfrm>
            <a:off x="4644167" y="197198"/>
            <a:ext cx="4234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b="1" u="sng" dirty="0">
                <a:latin typeface="Arial" panose="020B0604020202020204" pitchFamily="34" charset="0"/>
                <a:cs typeface="Arial" panose="020B0604020202020204" pitchFamily="34" charset="0"/>
              </a:rPr>
              <a:t> 03: Cell </a:t>
            </a:r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de-DE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1634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1FF474BC-1383-4F34-B625-EA150227C810}"/>
              </a:ext>
            </a:extLst>
          </p:cNvPr>
          <p:cNvSpPr txBox="1"/>
          <p:nvPr/>
        </p:nvSpPr>
        <p:spPr>
          <a:xfrm>
            <a:off x="355600" y="1027699"/>
            <a:ext cx="6629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Table 1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: total viable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alculat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cover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fter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por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has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4 – 6</a:t>
            </a:r>
          </a:p>
        </p:txBody>
      </p:sp>
      <p:sp>
        <p:nvSpPr>
          <p:cNvPr id="3" name="Foliennummernplatzhalter 2">
            <a:extLst>
              <a:ext uri="{FF2B5EF4-FFF2-40B4-BE49-F238E27FC236}">
                <a16:creationId xmlns:a16="http://schemas.microsoft.com/office/drawing/2014/main" id="{53CC49FF-5E0F-4D4B-B3B1-1B15157F7B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2</a:t>
            </a:fld>
            <a:endParaRPr lang="de-DE"/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719C88E3-28F0-4C53-9719-6F5B30BDD7BB}"/>
              </a:ext>
            </a:extLst>
          </p:cNvPr>
          <p:cNvSpPr txBox="1"/>
          <p:nvPr/>
        </p:nvSpPr>
        <p:spPr>
          <a:xfrm>
            <a:off x="4644167" y="197198"/>
            <a:ext cx="4234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b="1" u="sng" dirty="0">
                <a:latin typeface="Arial" panose="020B0604020202020204" pitchFamily="34" charset="0"/>
                <a:cs typeface="Arial" panose="020B0604020202020204" pitchFamily="34" charset="0"/>
              </a:rPr>
              <a:t> 03: Cell </a:t>
            </a:r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de-DE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id="{1A20E765-A9D6-4BD0-BAE0-A22CB64CE2B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5275617"/>
              </p:ext>
            </p:extLst>
          </p:nvPr>
        </p:nvGraphicFramePr>
        <p:xfrm>
          <a:off x="355600" y="1447225"/>
          <a:ext cx="12598400" cy="385232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80088">
                  <a:extLst>
                    <a:ext uri="{9D8B030D-6E8A-4147-A177-3AD203B41FA5}">
                      <a16:colId xmlns:a16="http://schemas.microsoft.com/office/drawing/2014/main" val="2806400149"/>
                    </a:ext>
                  </a:extLst>
                </a:gridCol>
                <a:gridCol w="780088">
                  <a:extLst>
                    <a:ext uri="{9D8B030D-6E8A-4147-A177-3AD203B41FA5}">
                      <a16:colId xmlns:a16="http://schemas.microsoft.com/office/drawing/2014/main" val="578608756"/>
                    </a:ext>
                  </a:extLst>
                </a:gridCol>
                <a:gridCol w="1014112">
                  <a:extLst>
                    <a:ext uri="{9D8B030D-6E8A-4147-A177-3AD203B41FA5}">
                      <a16:colId xmlns:a16="http://schemas.microsoft.com/office/drawing/2014/main" val="3618978709"/>
                    </a:ext>
                  </a:extLst>
                </a:gridCol>
                <a:gridCol w="972834">
                  <a:extLst>
                    <a:ext uri="{9D8B030D-6E8A-4147-A177-3AD203B41FA5}">
                      <a16:colId xmlns:a16="http://schemas.microsoft.com/office/drawing/2014/main" val="3209909587"/>
                    </a:ext>
                  </a:extLst>
                </a:gridCol>
                <a:gridCol w="1318671">
                  <a:extLst>
                    <a:ext uri="{9D8B030D-6E8A-4147-A177-3AD203B41FA5}">
                      <a16:colId xmlns:a16="http://schemas.microsoft.com/office/drawing/2014/main" val="3677321595"/>
                    </a:ext>
                  </a:extLst>
                </a:gridCol>
                <a:gridCol w="1316396">
                  <a:extLst>
                    <a:ext uri="{9D8B030D-6E8A-4147-A177-3AD203B41FA5}">
                      <a16:colId xmlns:a16="http://schemas.microsoft.com/office/drawing/2014/main" val="2367443228"/>
                    </a:ext>
                  </a:extLst>
                </a:gridCol>
                <a:gridCol w="1550423">
                  <a:extLst>
                    <a:ext uri="{9D8B030D-6E8A-4147-A177-3AD203B41FA5}">
                      <a16:colId xmlns:a16="http://schemas.microsoft.com/office/drawing/2014/main" val="1422657299"/>
                    </a:ext>
                  </a:extLst>
                </a:gridCol>
                <a:gridCol w="1118124">
                  <a:extLst>
                    <a:ext uri="{9D8B030D-6E8A-4147-A177-3AD203B41FA5}">
                      <a16:colId xmlns:a16="http://schemas.microsoft.com/office/drawing/2014/main" val="1069670443"/>
                    </a:ext>
                  </a:extLst>
                </a:gridCol>
                <a:gridCol w="1378152">
                  <a:extLst>
                    <a:ext uri="{9D8B030D-6E8A-4147-A177-3AD203B41FA5}">
                      <a16:colId xmlns:a16="http://schemas.microsoft.com/office/drawing/2014/main" val="573583847"/>
                    </a:ext>
                  </a:extLst>
                </a:gridCol>
                <a:gridCol w="1092121">
                  <a:extLst>
                    <a:ext uri="{9D8B030D-6E8A-4147-A177-3AD203B41FA5}">
                      <a16:colId xmlns:a16="http://schemas.microsoft.com/office/drawing/2014/main" val="233655081"/>
                    </a:ext>
                  </a:extLst>
                </a:gridCol>
                <a:gridCol w="1277391">
                  <a:extLst>
                    <a:ext uri="{9D8B030D-6E8A-4147-A177-3AD203B41FA5}">
                      <a16:colId xmlns:a16="http://schemas.microsoft.com/office/drawing/2014/main" val="1593074747"/>
                    </a:ext>
                  </a:extLst>
                </a:gridCol>
              </a:tblGrid>
              <a:tr h="460808">
                <a:tc gridSpan="11"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viable cell count and recovery of each vessel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03101633"/>
                  </a:ext>
                </a:extLst>
              </a:tr>
              <a:tr h="580592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ssel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eding cell density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able </a:t>
                      </a:r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</a:t>
                      </a:r>
                      <a:b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overy</a:t>
                      </a:r>
                      <a:b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 [%]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able cells</a:t>
                      </a:r>
                      <a:b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g A in incubato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overy</a:t>
                      </a:r>
                      <a:b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g A in incubator [%]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able </a:t>
                      </a:r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</a:t>
                      </a:r>
                      <a:b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g</a:t>
                      </a:r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 in Cellbox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overy</a:t>
                      </a:r>
                      <a:b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g A in Cellbox [%]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able </a:t>
                      </a:r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</a:t>
                      </a:r>
                      <a:b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yopreserved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overy</a:t>
                      </a:r>
                      <a:b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yopreserved [%]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69883780"/>
                  </a:ext>
                </a:extLst>
              </a:tr>
              <a:tr h="460808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o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9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9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5.80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4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.86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9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solidFill>
                            <a:srgbClr val="FF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.22%</a:t>
                      </a:r>
                      <a:endParaRPr lang="de-DE" sz="1200" b="0" i="0" u="none" strike="noStrike" dirty="0">
                        <a:solidFill>
                          <a:srgbClr val="FF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0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22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9189227"/>
                  </a:ext>
                </a:extLst>
              </a:tr>
              <a:tr h="46080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5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5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9.66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7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3.24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3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6.15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.81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3230078"/>
                  </a:ext>
                </a:extLst>
              </a:tr>
              <a:tr h="48384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8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2.22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7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7.40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4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1.11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9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.01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345715"/>
                  </a:ext>
                </a:extLst>
              </a:tr>
              <a:tr h="460808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12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1E+08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1E+08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2.56%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3E+08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4.50%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9E+08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83%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0E+08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.35%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6659468"/>
                  </a:ext>
                </a:extLst>
              </a:tr>
              <a:tr h="460808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</a:t>
                      </a:r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v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2E+07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2E+07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94%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34E+06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86%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7E+06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45%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E+07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2%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14834020"/>
                  </a:ext>
                </a:extLst>
              </a:tr>
              <a:tr h="483848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l</a:t>
                      </a:r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v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.16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55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9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0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.35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20809286"/>
                  </a:ext>
                </a:extLst>
              </a:tr>
            </a:tbl>
          </a:graphicData>
        </a:graphic>
      </p:graphicFrame>
      <p:sp>
        <p:nvSpPr>
          <p:cNvPr id="9" name="Textfeld 8">
            <a:extLst>
              <a:ext uri="{FF2B5EF4-FFF2-40B4-BE49-F238E27FC236}">
                <a16:creationId xmlns:a16="http://schemas.microsoft.com/office/drawing/2014/main" id="{4DA6CED2-1315-4743-8BBB-C011C8A53916}"/>
              </a:ext>
            </a:extLst>
          </p:cNvPr>
          <p:cNvSpPr txBox="1"/>
          <p:nvPr/>
        </p:nvSpPr>
        <p:spPr>
          <a:xfrm>
            <a:off x="355600" y="5393478"/>
            <a:ext cx="117475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Note: 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mark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cover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sult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aus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n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dentifi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leckag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fter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por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has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The residual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volum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 was 25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m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nstea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35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m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eginning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por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has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92826688-2E78-4D88-8F0C-D3F95D2A25CB}"/>
              </a:ext>
            </a:extLst>
          </p:cNvPr>
          <p:cNvSpPr txBox="1"/>
          <p:nvPr/>
        </p:nvSpPr>
        <p:spPr>
          <a:xfrm>
            <a:off x="355600" y="6631617"/>
            <a:ext cx="6629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Table 2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Viabilit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ri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nd after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por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has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4 – 6</a:t>
            </a:r>
          </a:p>
        </p:txBody>
      </p:sp>
      <p:graphicFrame>
        <p:nvGraphicFramePr>
          <p:cNvPr id="5" name="Tabelle 4">
            <a:extLst>
              <a:ext uri="{FF2B5EF4-FFF2-40B4-BE49-F238E27FC236}">
                <a16:creationId xmlns:a16="http://schemas.microsoft.com/office/drawing/2014/main" id="{F1A15D20-8695-4DFC-987B-1DE8ABD943A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8071394"/>
              </p:ext>
            </p:extLst>
          </p:nvPr>
        </p:nvGraphicFramePr>
        <p:xfrm>
          <a:off x="444500" y="7053263"/>
          <a:ext cx="7543799" cy="114681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61039">
                  <a:extLst>
                    <a:ext uri="{9D8B030D-6E8A-4147-A177-3AD203B41FA5}">
                      <a16:colId xmlns:a16="http://schemas.microsoft.com/office/drawing/2014/main" val="994524213"/>
                    </a:ext>
                  </a:extLst>
                </a:gridCol>
                <a:gridCol w="761039">
                  <a:extLst>
                    <a:ext uri="{9D8B030D-6E8A-4147-A177-3AD203B41FA5}">
                      <a16:colId xmlns:a16="http://schemas.microsoft.com/office/drawing/2014/main" val="3796072285"/>
                    </a:ext>
                  </a:extLst>
                </a:gridCol>
                <a:gridCol w="989351">
                  <a:extLst>
                    <a:ext uri="{9D8B030D-6E8A-4147-A177-3AD203B41FA5}">
                      <a16:colId xmlns:a16="http://schemas.microsoft.com/office/drawing/2014/main" val="196073649"/>
                    </a:ext>
                  </a:extLst>
                </a:gridCol>
                <a:gridCol w="827630">
                  <a:extLst>
                    <a:ext uri="{9D8B030D-6E8A-4147-A177-3AD203B41FA5}">
                      <a16:colId xmlns:a16="http://schemas.microsoft.com/office/drawing/2014/main" val="4186998996"/>
                    </a:ext>
                  </a:extLst>
                </a:gridCol>
                <a:gridCol w="1407922">
                  <a:extLst>
                    <a:ext uri="{9D8B030D-6E8A-4147-A177-3AD203B41FA5}">
                      <a16:colId xmlns:a16="http://schemas.microsoft.com/office/drawing/2014/main" val="351917480"/>
                    </a:ext>
                  </a:extLst>
                </a:gridCol>
                <a:gridCol w="1284253">
                  <a:extLst>
                    <a:ext uri="{9D8B030D-6E8A-4147-A177-3AD203B41FA5}">
                      <a16:colId xmlns:a16="http://schemas.microsoft.com/office/drawing/2014/main" val="3479605336"/>
                    </a:ext>
                  </a:extLst>
                </a:gridCol>
                <a:gridCol w="1512565">
                  <a:extLst>
                    <a:ext uri="{9D8B030D-6E8A-4147-A177-3AD203B41FA5}">
                      <a16:colId xmlns:a16="http://schemas.microsoft.com/office/drawing/2014/main" val="969121573"/>
                    </a:ext>
                  </a:extLst>
                </a:gridCol>
              </a:tblGrid>
              <a:tr h="200025">
                <a:tc gridSpan="7"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ability</a:t>
                      </a:r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[%]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20000926"/>
                  </a:ext>
                </a:extLst>
              </a:tr>
              <a:tr h="2000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sse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or </a:t>
                      </a:r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port</a:t>
                      </a:r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g</a:t>
                      </a:r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 in </a:t>
                      </a:r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ubator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g</a:t>
                      </a:r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 in Cellbox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yopreserved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42196623"/>
                  </a:ext>
                </a:extLst>
              </a:tr>
              <a:tr h="19050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o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.5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1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1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3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2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6810082"/>
                  </a:ext>
                </a:extLst>
              </a:tr>
              <a:tr h="190500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1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3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2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3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1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8085389"/>
                  </a:ext>
                </a:extLst>
              </a:tr>
              <a:tr h="200025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5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7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4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.6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8664043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718200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>
            <a:extLst>
              <a:ext uri="{FF2B5EF4-FFF2-40B4-BE49-F238E27FC236}">
                <a16:creationId xmlns:a16="http://schemas.microsoft.com/office/drawing/2014/main" id="{1FF474BC-1383-4F34-B625-EA150227C810}"/>
              </a:ext>
            </a:extLst>
          </p:cNvPr>
          <p:cNvSpPr txBox="1"/>
          <p:nvPr/>
        </p:nvSpPr>
        <p:spPr>
          <a:xfrm>
            <a:off x="355600" y="1027699"/>
            <a:ext cx="6629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Table 3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: Total viable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alculat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cover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fter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cultivat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has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5 and 6</a:t>
            </a:r>
          </a:p>
        </p:txBody>
      </p:sp>
      <p:sp>
        <p:nvSpPr>
          <p:cNvPr id="3" name="Foliennummernplatzhalter 2">
            <a:extLst>
              <a:ext uri="{FF2B5EF4-FFF2-40B4-BE49-F238E27FC236}">
                <a16:creationId xmlns:a16="http://schemas.microsoft.com/office/drawing/2014/main" id="{53CC49FF-5E0F-4D4B-B3B1-1B15157F7B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A16D49-2449-4109-BE83-049B41A6F977}" type="slidenum">
              <a:rPr lang="de-DE" smtClean="0"/>
              <a:t>3</a:t>
            </a:fld>
            <a:endParaRPr lang="de-DE"/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719C88E3-28F0-4C53-9719-6F5B30BDD7BB}"/>
              </a:ext>
            </a:extLst>
          </p:cNvPr>
          <p:cNvSpPr txBox="1"/>
          <p:nvPr/>
        </p:nvSpPr>
        <p:spPr>
          <a:xfrm>
            <a:off x="4644167" y="197198"/>
            <a:ext cx="42347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data</a:t>
            </a:r>
            <a:r>
              <a:rPr lang="de-DE" b="1" u="sng" dirty="0">
                <a:latin typeface="Arial" panose="020B0604020202020204" pitchFamily="34" charset="0"/>
                <a:cs typeface="Arial" panose="020B0604020202020204" pitchFamily="34" charset="0"/>
              </a:rPr>
              <a:t> 03: Cell </a:t>
            </a:r>
            <a:r>
              <a:rPr lang="de-DE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counts</a:t>
            </a:r>
            <a:endParaRPr lang="de-DE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4DA6CED2-1315-4743-8BBB-C011C8A53916}"/>
              </a:ext>
            </a:extLst>
          </p:cNvPr>
          <p:cNvSpPr txBox="1"/>
          <p:nvPr/>
        </p:nvSpPr>
        <p:spPr>
          <a:xfrm>
            <a:off x="355600" y="3671666"/>
            <a:ext cx="117475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Note: I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n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aus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n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dentifi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leckag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ag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 in Cellbox™ after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por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has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4,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urthe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cover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ate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- also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cultivat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-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alculat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5 and 6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nly</a:t>
            </a:r>
            <a:endParaRPr lang="de-DE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92826688-2E78-4D88-8F0C-D3F95D2A25CB}"/>
              </a:ext>
            </a:extLst>
          </p:cNvPr>
          <p:cNvSpPr txBox="1"/>
          <p:nvPr/>
        </p:nvSpPr>
        <p:spPr>
          <a:xfrm>
            <a:off x="355600" y="4298909"/>
            <a:ext cx="112522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Table 4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: Overall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cover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ag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 in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ncubat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ag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 in Cellbox and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ryopreserv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aw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NK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as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eed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xpand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anspor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cultivat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hase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5 and 6</a:t>
            </a:r>
          </a:p>
        </p:txBody>
      </p:sp>
      <p:graphicFrame>
        <p:nvGraphicFramePr>
          <p:cNvPr id="12" name="Tabelle 11">
            <a:extLst>
              <a:ext uri="{FF2B5EF4-FFF2-40B4-BE49-F238E27FC236}">
                <a16:creationId xmlns:a16="http://schemas.microsoft.com/office/drawing/2014/main" id="{32FFAA96-6034-43E4-B821-FA6307BAB39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47902314"/>
              </p:ext>
            </p:extLst>
          </p:nvPr>
        </p:nvGraphicFramePr>
        <p:xfrm>
          <a:off x="355600" y="1473363"/>
          <a:ext cx="11391900" cy="205311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09023">
                  <a:extLst>
                    <a:ext uri="{9D8B030D-6E8A-4147-A177-3AD203B41FA5}">
                      <a16:colId xmlns:a16="http://schemas.microsoft.com/office/drawing/2014/main" val="1920417469"/>
                    </a:ext>
                  </a:extLst>
                </a:gridCol>
                <a:gridCol w="1086697">
                  <a:extLst>
                    <a:ext uri="{9D8B030D-6E8A-4147-A177-3AD203B41FA5}">
                      <a16:colId xmlns:a16="http://schemas.microsoft.com/office/drawing/2014/main" val="3336335976"/>
                    </a:ext>
                  </a:extLst>
                </a:gridCol>
                <a:gridCol w="1611627">
                  <a:extLst>
                    <a:ext uri="{9D8B030D-6E8A-4147-A177-3AD203B41FA5}">
                      <a16:colId xmlns:a16="http://schemas.microsoft.com/office/drawing/2014/main" val="2326971110"/>
                    </a:ext>
                  </a:extLst>
                </a:gridCol>
                <a:gridCol w="1633115">
                  <a:extLst>
                    <a:ext uri="{9D8B030D-6E8A-4147-A177-3AD203B41FA5}">
                      <a16:colId xmlns:a16="http://schemas.microsoft.com/office/drawing/2014/main" val="3232368271"/>
                    </a:ext>
                  </a:extLst>
                </a:gridCol>
                <a:gridCol w="1464278">
                  <a:extLst>
                    <a:ext uri="{9D8B030D-6E8A-4147-A177-3AD203B41FA5}">
                      <a16:colId xmlns:a16="http://schemas.microsoft.com/office/drawing/2014/main" val="3114602512"/>
                    </a:ext>
                  </a:extLst>
                </a:gridCol>
                <a:gridCol w="1313859">
                  <a:extLst>
                    <a:ext uri="{9D8B030D-6E8A-4147-A177-3AD203B41FA5}">
                      <a16:colId xmlns:a16="http://schemas.microsoft.com/office/drawing/2014/main" val="289011619"/>
                    </a:ext>
                  </a:extLst>
                </a:gridCol>
                <a:gridCol w="1854139">
                  <a:extLst>
                    <a:ext uri="{9D8B030D-6E8A-4147-A177-3AD203B41FA5}">
                      <a16:colId xmlns:a16="http://schemas.microsoft.com/office/drawing/2014/main" val="2555662853"/>
                    </a:ext>
                  </a:extLst>
                </a:gridCol>
                <a:gridCol w="1019162">
                  <a:extLst>
                    <a:ext uri="{9D8B030D-6E8A-4147-A177-3AD203B41FA5}">
                      <a16:colId xmlns:a16="http://schemas.microsoft.com/office/drawing/2014/main" val="4192329143"/>
                    </a:ext>
                  </a:extLst>
                </a:gridCol>
              </a:tblGrid>
              <a:tr h="184136">
                <a:tc gridSpan="8"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viable cell count and recovery of each vessel after recultivation phas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75634330"/>
                  </a:ext>
                </a:extLst>
              </a:tr>
              <a:tr h="929888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sse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eding cell density</a:t>
                      </a:r>
                      <a:b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om bag A in Cellbox into 1 x G-Rex ® 2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able cells</a:t>
                      </a:r>
                      <a:b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 transported NK cells in bag A and Cellbox </a:t>
                      </a:r>
                      <a:b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ultivated in 1x G-Rex® 2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overy</a:t>
                      </a:r>
                      <a:b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 [%]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eding cell density</a:t>
                      </a:r>
                      <a:b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om thawed NK cells into 1 x G-Rex ® 2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able cells</a:t>
                      </a:r>
                      <a:b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 thawed NK cells cultivated in 1x G-Rex® 2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overy</a:t>
                      </a:r>
                      <a:b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g A in incubator [%]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89399948"/>
                  </a:ext>
                </a:extLst>
              </a:tr>
              <a:tr h="18413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or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5E+07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0E+07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8.70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7E+07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1E+07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.92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8316229"/>
                  </a:ext>
                </a:extLst>
              </a:tr>
              <a:tr h="193343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5E+07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6E+07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3.39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9E+07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2E+07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33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8071786"/>
                  </a:ext>
                </a:extLst>
              </a:tr>
              <a:tr h="184136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12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verage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0E+07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8E+07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6.04%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3E+07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2E+07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.62%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5854497"/>
                  </a:ext>
                </a:extLst>
              </a:tr>
              <a:tr h="184136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 dev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9E+05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9E+05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6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66E+05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0E+06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4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57920391"/>
                  </a:ext>
                </a:extLst>
              </a:tr>
              <a:tr h="193343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l dev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6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0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9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16175043"/>
                  </a:ext>
                </a:extLst>
              </a:tr>
            </a:tbl>
          </a:graphicData>
        </a:graphic>
      </p:graphicFrame>
      <p:graphicFrame>
        <p:nvGraphicFramePr>
          <p:cNvPr id="13" name="Tabelle 12">
            <a:extLst>
              <a:ext uri="{FF2B5EF4-FFF2-40B4-BE49-F238E27FC236}">
                <a16:creationId xmlns:a16="http://schemas.microsoft.com/office/drawing/2014/main" id="{E5A069F9-3E27-4A9C-9907-4F1CD9B43E4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8658373"/>
              </p:ext>
            </p:extLst>
          </p:nvPr>
        </p:nvGraphicFramePr>
        <p:xfrm>
          <a:off x="355599" y="4786361"/>
          <a:ext cx="11391901" cy="201168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25005">
                  <a:extLst>
                    <a:ext uri="{9D8B030D-6E8A-4147-A177-3AD203B41FA5}">
                      <a16:colId xmlns:a16="http://schemas.microsoft.com/office/drawing/2014/main" val="1290443248"/>
                    </a:ext>
                  </a:extLst>
                </a:gridCol>
                <a:gridCol w="865766">
                  <a:extLst>
                    <a:ext uri="{9D8B030D-6E8A-4147-A177-3AD203B41FA5}">
                      <a16:colId xmlns:a16="http://schemas.microsoft.com/office/drawing/2014/main" val="873648853"/>
                    </a:ext>
                  </a:extLst>
                </a:gridCol>
                <a:gridCol w="1283973">
                  <a:extLst>
                    <a:ext uri="{9D8B030D-6E8A-4147-A177-3AD203B41FA5}">
                      <a16:colId xmlns:a16="http://schemas.microsoft.com/office/drawing/2014/main" val="2358912912"/>
                    </a:ext>
                  </a:extLst>
                </a:gridCol>
                <a:gridCol w="1298647">
                  <a:extLst>
                    <a:ext uri="{9D8B030D-6E8A-4147-A177-3AD203B41FA5}">
                      <a16:colId xmlns:a16="http://schemas.microsoft.com/office/drawing/2014/main" val="138671112"/>
                    </a:ext>
                  </a:extLst>
                </a:gridCol>
                <a:gridCol w="1166581">
                  <a:extLst>
                    <a:ext uri="{9D8B030D-6E8A-4147-A177-3AD203B41FA5}">
                      <a16:colId xmlns:a16="http://schemas.microsoft.com/office/drawing/2014/main" val="262054734"/>
                    </a:ext>
                  </a:extLst>
                </a:gridCol>
                <a:gridCol w="1041853">
                  <a:extLst>
                    <a:ext uri="{9D8B030D-6E8A-4147-A177-3AD203B41FA5}">
                      <a16:colId xmlns:a16="http://schemas.microsoft.com/office/drawing/2014/main" val="3569221575"/>
                    </a:ext>
                  </a:extLst>
                </a:gridCol>
                <a:gridCol w="1474735">
                  <a:extLst>
                    <a:ext uri="{9D8B030D-6E8A-4147-A177-3AD203B41FA5}">
                      <a16:colId xmlns:a16="http://schemas.microsoft.com/office/drawing/2014/main" val="3202791960"/>
                    </a:ext>
                  </a:extLst>
                </a:gridCol>
                <a:gridCol w="807069">
                  <a:extLst>
                    <a:ext uri="{9D8B030D-6E8A-4147-A177-3AD203B41FA5}">
                      <a16:colId xmlns:a16="http://schemas.microsoft.com/office/drawing/2014/main" val="3382927301"/>
                    </a:ext>
                  </a:extLst>
                </a:gridCol>
                <a:gridCol w="1164136">
                  <a:extLst>
                    <a:ext uri="{9D8B030D-6E8A-4147-A177-3AD203B41FA5}">
                      <a16:colId xmlns:a16="http://schemas.microsoft.com/office/drawing/2014/main" val="2700574041"/>
                    </a:ext>
                  </a:extLst>
                </a:gridCol>
                <a:gridCol w="1164136">
                  <a:extLst>
                    <a:ext uri="{9D8B030D-6E8A-4147-A177-3AD203B41FA5}">
                      <a16:colId xmlns:a16="http://schemas.microsoft.com/office/drawing/2014/main" val="3960197524"/>
                    </a:ext>
                  </a:extLst>
                </a:gridCol>
              </a:tblGrid>
              <a:tr h="163208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overy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ansport phase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ultivation</a:t>
                      </a:r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hase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Frutiger LT Com 45 Light" panose="020B0303030504020204" pitchFamily="34" charset="0"/>
                        </a:rPr>
                        <a:t>Overall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4844336"/>
                  </a:ext>
                </a:extLst>
              </a:tr>
              <a:tr h="163208"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tform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nor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able cells per vesse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 of transport phase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entage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iable cells per vessel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 of recultivation phase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entage [%]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centage</a:t>
                      </a:r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[%]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Frutiger LT Com 45 Light" panose="020B0303030504020204" pitchFamily="34" charset="0"/>
                        </a:rPr>
                        <a:t>percentage [%]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59904725"/>
                  </a:ext>
                </a:extLst>
              </a:tr>
              <a:tr h="16320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ubator</a:t>
                      </a:r>
                      <a:b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5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5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9.66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Frutiger LT Com 45 Light" panose="020B0303030504020204" pitchFamily="34" charset="0"/>
                        </a:rPr>
                        <a:t>NA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9197651"/>
                  </a:ext>
                </a:extLst>
              </a:tr>
              <a:tr h="1713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8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2.22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Frutiger LT Com 45 Light" panose="020B0303030504020204" pitchFamily="34" charset="0"/>
                        </a:rPr>
                        <a:t>NA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10407593"/>
                  </a:ext>
                </a:extLst>
              </a:tr>
              <a:tr h="16320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ubator</a:t>
                      </a:r>
                      <a:b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g</a:t>
                      </a:r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5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7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3.24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Frutiger LT Com 45 Light" panose="020B0303030504020204" pitchFamily="34" charset="0"/>
                        </a:rPr>
                        <a:t>NA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1848684"/>
                  </a:ext>
                </a:extLst>
              </a:tr>
              <a:tr h="1713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7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7.40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Frutiger LT Com 45 Light" panose="020B0303030504020204" pitchFamily="34" charset="0"/>
                        </a:rPr>
                        <a:t>NA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73832668"/>
                  </a:ext>
                </a:extLst>
              </a:tr>
              <a:tr h="16320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box</a:t>
                      </a:r>
                      <a:b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g</a:t>
                      </a:r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5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3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6.15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5E+07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0E+07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8.70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5.99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Frutiger LT Com 45 Light" panose="020B0303030504020204" pitchFamily="34" charset="0"/>
                        </a:rPr>
                        <a:t>125.99%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15461279"/>
                  </a:ext>
                </a:extLst>
              </a:tr>
              <a:tr h="1713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4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1.11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5E+07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6E+07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3.39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5.98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9343843"/>
                  </a:ext>
                </a:extLst>
              </a:tr>
              <a:tr h="16320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yopreserved</a:t>
                      </a:r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K </a:t>
                      </a:r>
                      <a:r>
                        <a:rPr lang="de-DE" sz="120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s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0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0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.43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7E+07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1E+07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.92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.94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Frutiger LT Com 45 Light" panose="020B0303030504020204" pitchFamily="34" charset="0"/>
                        </a:rPr>
                        <a:t>50.29%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14247743"/>
                  </a:ext>
                </a:extLst>
              </a:tr>
              <a:tr h="171368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0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9E+08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50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9E+07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2E+07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.33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.63%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03085524"/>
                  </a:ext>
                </a:extLst>
              </a:tr>
            </a:tbl>
          </a:graphicData>
        </a:graphic>
      </p:graphicFrame>
      <p:sp>
        <p:nvSpPr>
          <p:cNvPr id="15" name="Textfeld 14">
            <a:extLst>
              <a:ext uri="{FF2B5EF4-FFF2-40B4-BE49-F238E27FC236}">
                <a16:creationId xmlns:a16="http://schemas.microsoft.com/office/drawing/2014/main" id="{F09C9891-803A-492F-99A4-67DD2302A1C0}"/>
              </a:ext>
            </a:extLst>
          </p:cNvPr>
          <p:cNvSpPr txBox="1"/>
          <p:nvPr/>
        </p:nvSpPr>
        <p:spPr>
          <a:xfrm>
            <a:off x="355599" y="7025647"/>
            <a:ext cx="6629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Table 5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Viabilitie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ri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nd after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cultivat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has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5 – 6</a:t>
            </a:r>
          </a:p>
        </p:txBody>
      </p:sp>
      <p:graphicFrame>
        <p:nvGraphicFramePr>
          <p:cNvPr id="16" name="Tabelle 15">
            <a:extLst>
              <a:ext uri="{FF2B5EF4-FFF2-40B4-BE49-F238E27FC236}">
                <a16:creationId xmlns:a16="http://schemas.microsoft.com/office/drawing/2014/main" id="{BA4A2834-C6D2-4DA6-9940-533D6E401CF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6063033"/>
              </p:ext>
            </p:extLst>
          </p:nvPr>
        </p:nvGraphicFramePr>
        <p:xfrm>
          <a:off x="450850" y="7430328"/>
          <a:ext cx="9842500" cy="19335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57795">
                  <a:extLst>
                    <a:ext uri="{9D8B030D-6E8A-4147-A177-3AD203B41FA5}">
                      <a16:colId xmlns:a16="http://schemas.microsoft.com/office/drawing/2014/main" val="2452945309"/>
                    </a:ext>
                  </a:extLst>
                </a:gridCol>
                <a:gridCol w="1124313">
                  <a:extLst>
                    <a:ext uri="{9D8B030D-6E8A-4147-A177-3AD203B41FA5}">
                      <a16:colId xmlns:a16="http://schemas.microsoft.com/office/drawing/2014/main" val="2864947177"/>
                    </a:ext>
                  </a:extLst>
                </a:gridCol>
                <a:gridCol w="1667413">
                  <a:extLst>
                    <a:ext uri="{9D8B030D-6E8A-4147-A177-3AD203B41FA5}">
                      <a16:colId xmlns:a16="http://schemas.microsoft.com/office/drawing/2014/main" val="4054391009"/>
                    </a:ext>
                  </a:extLst>
                </a:gridCol>
                <a:gridCol w="1969135">
                  <a:extLst>
                    <a:ext uri="{9D8B030D-6E8A-4147-A177-3AD203B41FA5}">
                      <a16:colId xmlns:a16="http://schemas.microsoft.com/office/drawing/2014/main" val="4223875966"/>
                    </a:ext>
                  </a:extLst>
                </a:gridCol>
                <a:gridCol w="1514964">
                  <a:extLst>
                    <a:ext uri="{9D8B030D-6E8A-4147-A177-3AD203B41FA5}">
                      <a16:colId xmlns:a16="http://schemas.microsoft.com/office/drawing/2014/main" val="2221632028"/>
                    </a:ext>
                  </a:extLst>
                </a:gridCol>
                <a:gridCol w="2108880">
                  <a:extLst>
                    <a:ext uri="{9D8B030D-6E8A-4147-A177-3AD203B41FA5}">
                      <a16:colId xmlns:a16="http://schemas.microsoft.com/office/drawing/2014/main" val="1007037090"/>
                    </a:ext>
                  </a:extLst>
                </a:gridCol>
              </a:tblGrid>
              <a:tr h="190500">
                <a:tc gridSpan="6"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viability of each vessel </a:t>
                      </a:r>
                      <a:r>
                        <a:rPr lang="en-US" sz="1100" u="none" strike="noStrike">
                          <a:effectLst/>
                        </a:rPr>
                        <a:t>prior and after </a:t>
                      </a:r>
                      <a:r>
                        <a:rPr lang="en-US" sz="1100" u="none" strike="noStrike" dirty="0">
                          <a:effectLst/>
                        </a:rPr>
                        <a:t>recultivation phase [%]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4666247"/>
                  </a:ext>
                </a:extLst>
              </a:tr>
              <a:tr h="771525"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>
                          <a:effectLst/>
                        </a:rPr>
                        <a:t>vessel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viability prior cell seeding </a:t>
                      </a:r>
                      <a:br>
                        <a:rPr lang="en-US" sz="1100" u="none" strike="noStrike" dirty="0">
                          <a:effectLst/>
                        </a:rPr>
                      </a:br>
                      <a:r>
                        <a:rPr lang="en-US" sz="1100" u="none" strike="noStrike" dirty="0">
                          <a:effectLst/>
                        </a:rPr>
                        <a:t>of bag A in Cellbox into 1x G-Rex ® 2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viability after 3d recultivation phase of bag A in Cellbox into 1 x G-Rex ® 2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viability prior cell seeding of thawed NK cells into 1 x G-Rex ® 2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viability after 3d recultivation phase of thawed NK cells cultivated in 1x G-Rex® 2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6467150"/>
                  </a:ext>
                </a:extLst>
              </a:tr>
              <a:tr h="19050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>
                          <a:effectLst/>
                        </a:rPr>
                        <a:t>Donor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>
                          <a:effectLst/>
                        </a:rPr>
                        <a:t>5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</a:rPr>
                        <a:t>96.0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</a:rPr>
                        <a:t>98.4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</a:rPr>
                        <a:t>94.1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</a:rPr>
                        <a:t>98.8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93828928"/>
                  </a:ext>
                </a:extLst>
              </a:tr>
              <a:tr h="200025">
                <a:tc v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>
                          <a:effectLst/>
                        </a:rPr>
                        <a:t>6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</a:rPr>
                        <a:t>97.1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</a:rPr>
                        <a:t>99.2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</a:rPr>
                        <a:t>95.6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</a:rPr>
                        <a:t>98.7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7181486"/>
                  </a:ext>
                </a:extLst>
              </a:tr>
              <a:tr h="19050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1100" b="1" u="none" strike="noStrike" dirty="0" err="1">
                          <a:effectLst/>
                        </a:rPr>
                        <a:t>average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u="none" strike="noStrike" dirty="0">
                          <a:effectLst/>
                        </a:rPr>
                        <a:t>96.55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u="none" strike="noStrike" dirty="0">
                          <a:effectLst/>
                        </a:rPr>
                        <a:t>98.80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u="none" strike="noStrike" dirty="0">
                          <a:effectLst/>
                        </a:rPr>
                        <a:t>94.85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1" u="none" strike="noStrike" dirty="0">
                          <a:effectLst/>
                        </a:rPr>
                        <a:t>98.75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9166202"/>
                  </a:ext>
                </a:extLst>
              </a:tr>
              <a:tr h="190500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>
                          <a:effectLst/>
                        </a:rPr>
                        <a:t>st dev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</a:rPr>
                        <a:t>0.7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</a:rPr>
                        <a:t>0.5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</a:rPr>
                        <a:t>1.0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>
                          <a:effectLst/>
                        </a:rPr>
                        <a:t>0.07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1817065"/>
                  </a:ext>
                </a:extLst>
              </a:tr>
              <a:tr h="200025"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DE" sz="1100" u="none" strike="noStrike" dirty="0" err="1">
                          <a:effectLst/>
                        </a:rPr>
                        <a:t>rel</a:t>
                      </a:r>
                      <a:r>
                        <a:rPr lang="de-DE" sz="1100" u="none" strike="noStrike" dirty="0">
                          <a:effectLst/>
                        </a:rPr>
                        <a:t> </a:t>
                      </a:r>
                      <a:r>
                        <a:rPr lang="de-DE" sz="1100" u="none" strike="noStrike" dirty="0" err="1">
                          <a:effectLst/>
                        </a:rPr>
                        <a:t>dev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Frutiger LT Com 45 Light" panose="020B0303030504020204" pitchFamily="34" charset="0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Frutiger LT Com 45 Light" panose="020B0303030504020204" pitchFamily="34" charset="0"/>
                        </a:rPr>
                        <a:t>NA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Frutiger LT Com 45 Light" panose="020B0303030504020204" pitchFamily="34" charset="0"/>
                        </a:rPr>
                        <a:t>NA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>
                          <a:solidFill>
                            <a:srgbClr val="000000"/>
                          </a:solidFill>
                          <a:effectLst/>
                          <a:latin typeface="Frutiger LT Com 45 Light" panose="020B0303030504020204" pitchFamily="34" charset="0"/>
                        </a:rPr>
                        <a:t>NA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Frutiger LT Com 45 Light" panose="020B0303030504020204" pitchFamily="34" charset="0"/>
                        </a:rPr>
                        <a:t>NA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288306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529730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786679552C1A8E4993CBF6A23FAB2ED5" ma:contentTypeVersion="4" ma:contentTypeDescription="Ein neues Dokument erstellen." ma:contentTypeScope="" ma:versionID="1242b213505befe49d9e9c581dcaf711">
  <xsd:schema xmlns:xsd="http://www.w3.org/2001/XMLSchema" xmlns:xs="http://www.w3.org/2001/XMLSchema" xmlns:p="http://schemas.microsoft.com/office/2006/metadata/properties" xmlns:ns2="92c20cd1-3e4f-4a24-813b-8bbcc542bd4a" targetNamespace="http://schemas.microsoft.com/office/2006/metadata/properties" ma:root="true" ma:fieldsID="d2993d4b4c0543e65e074508ffe52722" ns2:_="">
    <xsd:import namespace="92c20cd1-3e4f-4a24-813b-8bbcc542bd4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2c20cd1-3e4f-4a24-813b-8bbcc542bd4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altstyp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18063B9C-3253-4E7D-A5B2-EE1E18D25CA5}"/>
</file>

<file path=customXml/itemProps2.xml><?xml version="1.0" encoding="utf-8"?>
<ds:datastoreItem xmlns:ds="http://schemas.openxmlformats.org/officeDocument/2006/customXml" ds:itemID="{427D4C47-0CCA-4DC5-BBC0-7618A1A76F54}"/>
</file>

<file path=customXml/itemProps3.xml><?xml version="1.0" encoding="utf-8"?>
<ds:datastoreItem xmlns:ds="http://schemas.openxmlformats.org/officeDocument/2006/customXml" ds:itemID="{8EA0428E-A682-4E69-819F-A67072319025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24</Words>
  <Application>Microsoft Office PowerPoint</Application>
  <PresentationFormat>Benutzerdefiniert</PresentationFormat>
  <Paragraphs>282</Paragraphs>
  <Slides>3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Frutiger LT Com 45 Light</vt:lpstr>
      <vt:lpstr>Office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ünkel, Anna</dc:creator>
  <cp:lastModifiedBy>Roßbach, Lutz</cp:lastModifiedBy>
  <cp:revision>116</cp:revision>
  <dcterms:created xsi:type="dcterms:W3CDTF">2024-08-07T11:10:13Z</dcterms:created>
  <dcterms:modified xsi:type="dcterms:W3CDTF">2025-04-10T07:22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86679552C1A8E4993CBF6A23FAB2ED5</vt:lpwstr>
  </property>
</Properties>
</file>